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10080625" cy="7559675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772400" cy="100584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772400" cy="10058400"/>
          </a:xfrm>
          <a:custGeom>
            <a:avLst/>
            <a:gdLst>
              <a:gd name="textAreaLeft" fmla="*/ 360 w 7772400"/>
              <a:gd name="textAreaRight" fmla="*/ 7772040 w 7772400"/>
              <a:gd name="textAreaTop" fmla="*/ 360 h 10058400"/>
              <a:gd name="textAreaBottom" fmla="*/ 10058040 h 10058400"/>
            </a:gdLst>
            <a:ahLst/>
            <a:rect l="textAreaLeft" t="textAreaTop" r="textAreaRight" b="textAreaBottom"/>
            <a:pathLst>
              <a:path w="21600" h="27953">
                <a:moveTo>
                  <a:pt x="4" y="0"/>
                </a:moveTo>
                <a:arcTo wR="4" hR="4" stAng="16200000" swAng="-5400000"/>
                <a:lnTo>
                  <a:pt x="0" y="27949"/>
                </a:lnTo>
                <a:arcTo wR="4" hR="4" stAng="10800000" swAng="-5400000"/>
                <a:lnTo>
                  <a:pt x="21596" y="27953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7772400" cy="10058400"/>
          </a:xfrm>
          <a:custGeom>
            <a:avLst/>
            <a:gdLst>
              <a:gd name="textAreaLeft" fmla="*/ 360 w 7772400"/>
              <a:gd name="textAreaRight" fmla="*/ 7772040 w 7772400"/>
              <a:gd name="textAreaTop" fmla="*/ 360 h 10058400"/>
              <a:gd name="textAreaBottom" fmla="*/ 10058040 h 10058400"/>
            </a:gdLst>
            <a:ahLst/>
            <a:rect l="textAreaLeft" t="textAreaTop" r="textAreaRight" b="textAreaBottom"/>
            <a:pathLst>
              <a:path w="21600" h="27953">
                <a:moveTo>
                  <a:pt x="4" y="0"/>
                </a:moveTo>
                <a:arcTo wR="4" hR="4" stAng="16200000" swAng="-5400000"/>
                <a:lnTo>
                  <a:pt x="0" y="27949"/>
                </a:lnTo>
                <a:arcTo wR="4" hR="4" stAng="10800000" swAng="-5400000"/>
                <a:lnTo>
                  <a:pt x="21596" y="27953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1"/>
          <p:cNvSpPr>
            <a:spLocks noGrp="1"/>
          </p:cNvSpPr>
          <p:nvPr>
            <p:ph type="sldImg"/>
          </p:nvPr>
        </p:nvSpPr>
        <p:spPr>
          <a:xfrm>
            <a:off x="1371240" y="763560"/>
            <a:ext cx="5024520" cy="376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777600" y="4776480"/>
            <a:ext cx="6213240" cy="4521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hdr"/>
          </p:nvPr>
        </p:nvSpPr>
        <p:spPr>
          <a:xfrm>
            <a:off x="-360" y="-360"/>
            <a:ext cx="3368520" cy="49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head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4"/>
          <p:cNvSpPr>
            <a:spLocks noGrp="1"/>
          </p:cNvSpPr>
          <p:nvPr>
            <p:ph type="dt" idx="4"/>
          </p:nvPr>
        </p:nvSpPr>
        <p:spPr>
          <a:xfrm>
            <a:off x="4398840" y="-360"/>
            <a:ext cx="3368880" cy="49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5"/>
          <p:cNvSpPr>
            <a:spLocks noGrp="1"/>
          </p:cNvSpPr>
          <p:nvPr>
            <p:ph type="ftr" idx="5"/>
          </p:nvPr>
        </p:nvSpPr>
        <p:spPr>
          <a:xfrm>
            <a:off x="-360" y="9554760"/>
            <a:ext cx="3368520" cy="49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6"/>
          <p:cNvSpPr>
            <a:spLocks noGrp="1"/>
          </p:cNvSpPr>
          <p:nvPr>
            <p:ph type="sldNum" idx="6"/>
          </p:nvPr>
        </p:nvSpPr>
        <p:spPr>
          <a:xfrm>
            <a:off x="4398840" y="9554760"/>
            <a:ext cx="3368880" cy="49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fld id="{BC840A24-4CB3-45A7-9493-A58738796FCB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211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213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215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CE703D-9900-4F0B-ACBD-0BF529D0DF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6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3280" y="4055760"/>
            <a:ext cx="9066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43CA4-ABD5-401C-9C3D-5B2DB0C343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49080" y="17679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3280" y="40557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49080" y="40557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BFA2A-D391-4438-88B9-76DFD79EFE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2919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040" y="1767960"/>
            <a:ext cx="2919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4440" y="1767960"/>
            <a:ext cx="2919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3280" y="4055760"/>
            <a:ext cx="2919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040" y="4055760"/>
            <a:ext cx="2919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4440" y="4055760"/>
            <a:ext cx="2919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11971-A8F0-471A-A6A9-EE471FE6F9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3280" y="1767960"/>
            <a:ext cx="90662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75E9D-E18B-4CEE-AF19-DF8CD12150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62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CA2CB3-9C09-473B-AE3A-9BE5E979C4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0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49080" y="1767960"/>
            <a:ext cx="44240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F4F61F-C98E-4696-B714-7B83B965FD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7963B-1097-4C21-B491-B1CDC376F0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3280" y="301680"/>
            <a:ext cx="9066240" cy="582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71ECF-4864-4587-919A-00C9B1845B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49080" y="1767960"/>
            <a:ext cx="44240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3280" y="40557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C7755-D10D-4917-8146-95687B4D4C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0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49080" y="17679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49080" y="40557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EC469-C70C-4860-9AC2-C37E3606F6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49080" y="1767960"/>
            <a:ext cx="44240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3280" y="4055760"/>
            <a:ext cx="9066240" cy="208908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3642C-5CF1-4F46-953F-D350A73551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3280" y="301680"/>
            <a:ext cx="9066240" cy="125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3280" y="1767960"/>
            <a:ext cx="9066240" cy="43801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3240" cy="5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7720" y="6886440"/>
            <a:ext cx="3190680" cy="5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360" y="6886440"/>
            <a:ext cx="2343240" cy="5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fld id="{C57DD808-D14D-4F1A-9D3A-C304EB5F6284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02920" y="17280"/>
            <a:ext cx="9070920" cy="1261800"/>
          </a:xfrm>
          <a:prstGeom prst="rect">
            <a:avLst/>
          </a:prstGeom>
          <a:noFill/>
          <a:ln w="0">
            <a:noFill/>
          </a:ln>
        </p:spPr>
        <p:txBody>
          <a:bodyPr lIns="0" rIns="0" tIns="3312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200240" y="2835360"/>
            <a:ext cx="8315280" cy="14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200240" y="5246640"/>
            <a:ext cx="8296200" cy="18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216080" y="508464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140000">
            <a:off x="247320" y="6075000"/>
            <a:ext cx="194148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_30802  58.3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60000">
            <a:off x="693720" y="2158560"/>
            <a:ext cx="9144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5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1200240" y="273168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 flipV="1">
            <a:off x="1195560" y="2830680"/>
            <a:ext cx="252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0" y="2651040"/>
            <a:ext cx="10969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liv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0" y="5099040"/>
            <a:ext cx="13716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raebn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080000">
            <a:off x="8972640" y="2193480"/>
            <a:ext cx="9144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2.5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9515520" y="273168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949644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140000">
            <a:off x="8704080" y="6036840"/>
            <a:ext cx="157608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1329  74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9504360" y="2835360"/>
            <a:ext cx="1584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1447920" y="2160720"/>
            <a:ext cx="9144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7.3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199404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140000">
            <a:off x="2598480" y="2160360"/>
            <a:ext cx="9144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9.6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3127320" y="27302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4182840" y="2122200"/>
            <a:ext cx="914400" cy="43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2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471816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5087880" y="2143080"/>
            <a:ext cx="9144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4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V="1">
            <a:off x="566100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5367240" y="2122200"/>
            <a:ext cx="914400" cy="438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5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V="1">
            <a:off x="5897520" y="27302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7315200" y="2160720"/>
            <a:ext cx="9144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9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7881840" y="273816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6320000">
            <a:off x="8107200" y="2161800"/>
            <a:ext cx="914400" cy="43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0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8632800" y="273816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H="1">
            <a:off x="3598920" y="2835360"/>
            <a:ext cx="112536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603600" y="508464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6020000">
            <a:off x="2661480" y="6053400"/>
            <a:ext cx="197172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1067  62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1503000" y="2835360"/>
            <a:ext cx="48420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H="1">
            <a:off x="2445840" y="2835360"/>
            <a:ext cx="69372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H="1">
            <a:off x="4751280" y="2835360"/>
            <a:ext cx="91440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H="1">
            <a:off x="4905360" y="2835360"/>
            <a:ext cx="100656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H="1">
            <a:off x="7785000" y="2835360"/>
            <a:ext cx="10656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H="1">
            <a:off x="8516880" y="2835360"/>
            <a:ext cx="130320" cy="24112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508040" y="508464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16140000">
            <a:off x="626760" y="6073200"/>
            <a:ext cx="194796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946  58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451240" y="508464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1442880" y="6055560"/>
            <a:ext cx="204948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184  60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754520" y="508464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6140000">
            <a:off x="3812400" y="6026760"/>
            <a:ext cx="18511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266  65.1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910040" y="508464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rot="16140000">
            <a:off x="4062240" y="6027120"/>
            <a:ext cx="18493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0635  65.4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79148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16080000">
            <a:off x="7006320" y="6004080"/>
            <a:ext cx="15937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904  70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852156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6140000">
            <a:off x="7663680" y="6034680"/>
            <a:ext cx="1720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0455  72.3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5157720" y="13586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8723160" y="13586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157720" y="1463760"/>
            <a:ext cx="3565440" cy="14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763596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6080000">
            <a:off x="6825240" y="6004080"/>
            <a:ext cx="15937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_30637  70.6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375160" y="1096920"/>
            <a:ext cx="4206960" cy="30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gnificant Region (Oliver et al. 201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7556400" y="6950160"/>
            <a:ext cx="237816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old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Markers Significant in Graebner et a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502920" y="17280"/>
            <a:ext cx="9070920" cy="1261800"/>
          </a:xfrm>
          <a:prstGeom prst="rect">
            <a:avLst/>
          </a:prstGeom>
          <a:noFill/>
          <a:ln w="0">
            <a:noFill/>
          </a:ln>
        </p:spPr>
        <p:txBody>
          <a:bodyPr lIns="0" rIns="0" tIns="3312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7H- First Group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216080" y="2835360"/>
            <a:ext cx="8292960" cy="14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949644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6260000">
            <a:off x="8995320" y="2099520"/>
            <a:ext cx="9144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9480600" y="273168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H="1" flipV="1">
            <a:off x="9475920" y="2830680"/>
            <a:ext cx="252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0" y="2651040"/>
            <a:ext cx="109692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liv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0" y="5099040"/>
            <a:ext cx="13716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raebn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200240" y="5246640"/>
            <a:ext cx="8296200" cy="18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21608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rot="16140000">
            <a:off x="427680" y="6033240"/>
            <a:ext cx="157464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_30296  1.1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rot="16260000">
            <a:off x="72792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V="1">
            <a:off x="1200240" y="273168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flipH="1" flipV="1">
            <a:off x="1195560" y="2830680"/>
            <a:ext cx="252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532116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rot="16260000">
            <a:off x="4461480" y="2099520"/>
            <a:ext cx="9144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4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V="1">
            <a:off x="491976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H="1" flipV="1">
            <a:off x="4903560" y="2830680"/>
            <a:ext cx="42228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27664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rot="16260000">
            <a:off x="1783440" y="2143800"/>
            <a:ext cx="9144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228600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2276640" y="2830680"/>
            <a:ext cx="936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56384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 rot="16260000">
            <a:off x="115020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1609560" y="27302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V="1">
            <a:off x="1563840" y="2830680"/>
            <a:ext cx="4572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38096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 rot="16260000">
            <a:off x="965880" y="2099520"/>
            <a:ext cx="9144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139068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1390680" y="2830680"/>
            <a:ext cx="144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6140000">
            <a:off x="572040" y="6032880"/>
            <a:ext cx="157464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1307  1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6140000">
            <a:off x="751320" y="6032880"/>
            <a:ext cx="157464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710  2.5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6140000">
            <a:off x="1508760" y="6033240"/>
            <a:ext cx="157464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1031  5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6140000">
            <a:off x="4567680" y="6032880"/>
            <a:ext cx="157464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0025  16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6140000">
            <a:off x="8794440" y="5944680"/>
            <a:ext cx="1575000" cy="43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162  32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flipV="1">
            <a:off x="4708440" y="13586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7369200" y="13586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708440" y="1463760"/>
            <a:ext cx="2660760" cy="14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475160" y="1096920"/>
            <a:ext cx="4206960" cy="30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gnificant Region (Oliver et al. 201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7556400" y="6950160"/>
            <a:ext cx="237816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old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Markers Significant in Graebner et a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502920" y="17280"/>
            <a:ext cx="9070920" cy="1261800"/>
          </a:xfrm>
          <a:prstGeom prst="rect">
            <a:avLst/>
          </a:prstGeom>
          <a:noFill/>
          <a:ln w="0">
            <a:noFill/>
          </a:ln>
        </p:spPr>
        <p:txBody>
          <a:bodyPr lIns="0" rIns="0" tIns="3312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7H- Third Group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217520" y="2835360"/>
            <a:ext cx="8263080" cy="14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217520" y="5246640"/>
            <a:ext cx="8293320" cy="180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21752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rot="16140000">
            <a:off x="379800" y="6223320"/>
            <a:ext cx="1666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354  127.4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rot="16260000">
            <a:off x="72936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1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1200240" y="273168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H="1" flipV="1">
            <a:off x="1197000" y="2830680"/>
            <a:ext cx="252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949644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rot="16260000">
            <a:off x="899712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31.5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9480600" y="273168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H="1" flipV="1">
            <a:off x="9475920" y="2830680"/>
            <a:ext cx="252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rot="16140000">
            <a:off x="8657640" y="6228720"/>
            <a:ext cx="16686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0547  166.5 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38948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rot="16140000">
            <a:off x="3583440" y="6223320"/>
            <a:ext cx="1666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2_10973  142.4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rot="16260000">
            <a:off x="116136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2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V="1">
            <a:off x="161928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H="1" flipV="1">
            <a:off x="1627200" y="2830680"/>
            <a:ext cx="140328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743436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rot="16140000">
            <a:off x="6607800" y="6223680"/>
            <a:ext cx="16668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1275  156.6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rot="16260000">
            <a:off x="666828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5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V="1">
            <a:off x="714060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flipH="1" flipV="1">
            <a:off x="7135920" y="2830680"/>
            <a:ext cx="30312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rot="16140000">
            <a:off x="5347080" y="6223320"/>
            <a:ext cx="1666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452  150.4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rot="16260000">
            <a:off x="6236280" y="2099520"/>
            <a:ext cx="9144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4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flipV="1">
            <a:off x="672156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6099120" y="2830680"/>
            <a:ext cx="60948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609912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rot="16140000">
            <a:off x="5167800" y="6223320"/>
            <a:ext cx="1666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1363  150.4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rot="16260000">
            <a:off x="580464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3.9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>
            <a:off x="629136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V="1">
            <a:off x="6099120" y="2830680"/>
            <a:ext cx="17784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15772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rot="16140000">
            <a:off x="4410720" y="6223680"/>
            <a:ext cx="16668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10687  146.0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rot="16260000">
            <a:off x="468864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1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V="1">
            <a:off x="514836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5157720" y="2830680"/>
            <a:ext cx="324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09256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rot="16140000">
            <a:off x="4267800" y="6223680"/>
            <a:ext cx="16668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1_20847  145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rot="16260000">
            <a:off x="450936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20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V="1">
            <a:off x="497520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H="1" flipV="1">
            <a:off x="4975200" y="2830680"/>
            <a:ext cx="1224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417816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rot="16140000">
            <a:off x="3373920" y="6223320"/>
            <a:ext cx="1666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_10797  141.4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rot="16260000">
            <a:off x="3177360" y="2099160"/>
            <a:ext cx="9144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7.7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V="1">
            <a:off x="3657600" y="27302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flipH="1" flipV="1">
            <a:off x="3643200" y="2830680"/>
            <a:ext cx="54000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62124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rot="16140000">
            <a:off x="2791440" y="6223680"/>
            <a:ext cx="16668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_10861  138.8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rot="16260000">
            <a:off x="2132640" y="2099520"/>
            <a:ext cx="9144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5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V="1">
            <a:off x="2597040" y="2730240"/>
            <a:ext cx="180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H="1" flipV="1">
            <a:off x="2599920" y="2830680"/>
            <a:ext cx="1025640" cy="24206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3025800" y="5121360"/>
            <a:ext cx="144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rot="16140000">
            <a:off x="2215080" y="6223320"/>
            <a:ext cx="166680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_21209  136.0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4983120" y="5121360"/>
            <a:ext cx="1800" cy="27468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 rot="16140000">
            <a:off x="4123440" y="6223680"/>
            <a:ext cx="16668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1_10885  145.2 c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flipV="1">
            <a:off x="3191040" y="13586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 flipV="1">
            <a:off x="7315200" y="1358640"/>
            <a:ext cx="1440" cy="19836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191040" y="1463760"/>
            <a:ext cx="4124160" cy="1440"/>
          </a:xfrm>
          <a:prstGeom prst="line">
            <a:avLst/>
          </a:prstGeom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3611520" y="1096920"/>
            <a:ext cx="4206960" cy="30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gnificant Region (Oliver et al. 201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7556400" y="6950160"/>
            <a:ext cx="237816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old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Markers Significant in Graebner et al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-66600" y="2676600"/>
            <a:ext cx="109692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liv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-85680" y="5124600"/>
            <a:ext cx="1371600" cy="26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raebn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25T19:43:51Z</dcterms:created>
  <dc:creator/>
  <dc:description/>
  <dc:language>en-US</dc:language>
  <cp:lastModifiedBy/>
  <cp:lastPrinted>2014-11-25T21:58:50Z</cp:lastPrinted>
  <dcterms:modified xsi:type="dcterms:W3CDTF">2014-11-26T01:02:26Z</dcterms:modified>
  <cp:revision>9</cp:revision>
  <dc:subject/>
  <dc:title/>
</cp:coreProperties>
</file>